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0" r:id="rId2"/>
    <p:sldId id="256" r:id="rId3"/>
    <p:sldId id="257" r:id="rId4"/>
    <p:sldId id="258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bertaitken/Desktop/Alena%20paper%203/Project%203%20Results%20Alena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-Calcium'!$T$39:$T$42</c:f>
                <c:numCache>
                  <c:formatCode>General</c:formatCode>
                  <c:ptCount val="4"/>
                  <c:pt idx="0">
                    <c:v>4.5642524</c:v>
                  </c:pt>
                  <c:pt idx="1">
                    <c:v>3.9123649999999999</c:v>
                  </c:pt>
                  <c:pt idx="2">
                    <c:v>3.4997142999999999</c:v>
                  </c:pt>
                  <c:pt idx="3">
                    <c:v>3.48229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-Calcium'!$R$39:$R$42</c:f>
              <c:strCache>
                <c:ptCount val="4"/>
                <c:pt idx="0">
                  <c:v>S1EC</c:v>
                </c:pt>
                <c:pt idx="1">
                  <c:v>S1EC 1/2 CaCl2</c:v>
                </c:pt>
                <c:pt idx="2">
                  <c:v>S1EC 1/4 CaCl2</c:v>
                </c:pt>
                <c:pt idx="3">
                  <c:v>Quinns</c:v>
                </c:pt>
              </c:strCache>
            </c:strRef>
          </c:cat>
          <c:val>
            <c:numRef>
              <c:f>'S1EC-Calcium'!$S$39:$S$42</c:f>
              <c:numCache>
                <c:formatCode>General</c:formatCode>
                <c:ptCount val="4"/>
                <c:pt idx="0">
                  <c:v>27.32</c:v>
                </c:pt>
                <c:pt idx="1">
                  <c:v>19.64</c:v>
                </c:pt>
                <c:pt idx="2">
                  <c:v>20.9</c:v>
                </c:pt>
                <c:pt idx="3">
                  <c:v>23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69-624E-AF71-37AB5361CD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4338816"/>
        <c:axId val="1354340528"/>
      </c:barChart>
      <c:catAx>
        <c:axId val="1354338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54340528"/>
        <c:crosses val="autoZero"/>
        <c:auto val="1"/>
        <c:lblAlgn val="ctr"/>
        <c:lblOffset val="100"/>
        <c:noMultiLvlLbl val="0"/>
      </c:catAx>
      <c:valAx>
        <c:axId val="1354340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54338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74759405074365"/>
          <c:y val="0.1608434931571974"/>
          <c:w val="0.52103018372703402"/>
          <c:h val="0.6213903537481392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Ergothioneine'!$AC$53:$AC$57</c:f>
                <c:numCache>
                  <c:formatCode>General</c:formatCode>
                  <c:ptCount val="5"/>
                  <c:pt idx="0">
                    <c:v>3.0550505000000001</c:v>
                  </c:pt>
                  <c:pt idx="1">
                    <c:v>2.3333333000000001</c:v>
                  </c:pt>
                  <c:pt idx="2">
                    <c:v>2</c:v>
                  </c:pt>
                  <c:pt idx="3">
                    <c:v>3.6666666999999999</c:v>
                  </c:pt>
                  <c:pt idx="4">
                    <c:v>6.350852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Ergothioneine'!$AA$53:$AA$57</c:f>
              <c:strCache>
                <c:ptCount val="5"/>
                <c:pt idx="0">
                  <c:v>S1EC</c:v>
                </c:pt>
                <c:pt idx="1">
                  <c:v>S1EC+ERT 4mM</c:v>
                </c:pt>
                <c:pt idx="2">
                  <c:v>S1EC+ERT 6mM</c:v>
                </c:pt>
                <c:pt idx="3">
                  <c:v>S1EC+ERT 8mM</c:v>
                </c:pt>
                <c:pt idx="4">
                  <c:v>Quinns</c:v>
                </c:pt>
              </c:strCache>
            </c:strRef>
          </c:cat>
          <c:val>
            <c:numRef>
              <c:f>'S1EC+Ergothioneine'!$AB$53:$AB$57</c:f>
              <c:numCache>
                <c:formatCode>General</c:formatCode>
                <c:ptCount val="5"/>
                <c:pt idx="0">
                  <c:v>23</c:v>
                </c:pt>
                <c:pt idx="1">
                  <c:v>23.333333</c:v>
                </c:pt>
                <c:pt idx="2">
                  <c:v>24</c:v>
                </c:pt>
                <c:pt idx="3">
                  <c:v>24.333333</c:v>
                </c:pt>
                <c:pt idx="4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4E-AE41-9970-EC2B3AA4C2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570784"/>
        <c:axId val="1379455216"/>
      </c:barChart>
      <c:catAx>
        <c:axId val="1379570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455216"/>
        <c:crosses val="autoZero"/>
        <c:auto val="1"/>
        <c:lblAlgn val="ctr"/>
        <c:lblOffset val="100"/>
        <c:noMultiLvlLbl val="0"/>
      </c:catAx>
      <c:valAx>
        <c:axId val="1379455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570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30314960629921"/>
          <c:y val="5.3429141179143283E-2"/>
          <c:w val="0.52103018372703414"/>
          <c:h val="0.672767669108552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Ergothioneine'!$V$53:$V$57</c:f>
                <c:numCache>
                  <c:formatCode>General</c:formatCode>
                  <c:ptCount val="5"/>
                  <c:pt idx="0">
                    <c:v>15.1</c:v>
                  </c:pt>
                  <c:pt idx="1">
                    <c:v>14.566667000000001</c:v>
                  </c:pt>
                  <c:pt idx="2">
                    <c:v>14.966666999999999</c:v>
                  </c:pt>
                  <c:pt idx="3">
                    <c:v>14.133333</c:v>
                  </c:pt>
                  <c:pt idx="4">
                    <c:v>9.1333333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Ergothioneine'!$U$53:$U$57</c:f>
              <c:strCache>
                <c:ptCount val="5"/>
                <c:pt idx="0">
                  <c:v>S1EC</c:v>
                </c:pt>
                <c:pt idx="1">
                  <c:v>S1EC+ERT 4mM</c:v>
                </c:pt>
                <c:pt idx="2">
                  <c:v>S1EC+ERT 6mM</c:v>
                </c:pt>
                <c:pt idx="3">
                  <c:v>S1EC+ERT 8mM</c:v>
                </c:pt>
                <c:pt idx="4">
                  <c:v>Quinns</c:v>
                </c:pt>
              </c:strCache>
            </c:strRef>
          </c:cat>
          <c:val>
            <c:numRef>
              <c:f>'S1EC+Ergothioneine'!$V$53:$V$57</c:f>
              <c:numCache>
                <c:formatCode>General</c:formatCode>
                <c:ptCount val="5"/>
                <c:pt idx="0">
                  <c:v>15.1</c:v>
                </c:pt>
                <c:pt idx="1">
                  <c:v>14.566667000000001</c:v>
                </c:pt>
                <c:pt idx="2">
                  <c:v>14.966666999999999</c:v>
                </c:pt>
                <c:pt idx="3">
                  <c:v>14.133333</c:v>
                </c:pt>
                <c:pt idx="4">
                  <c:v>9.1333333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C4-ED43-9BC5-6E3BAC7FB4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1218528"/>
        <c:axId val="1811299904"/>
      </c:barChart>
      <c:catAx>
        <c:axId val="1811218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1299904"/>
        <c:crosses val="autoZero"/>
        <c:auto val="1"/>
        <c:lblAlgn val="ctr"/>
        <c:lblOffset val="100"/>
        <c:noMultiLvlLbl val="0"/>
      </c:catAx>
      <c:valAx>
        <c:axId val="1811299904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218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79155730533677"/>
          <c:y val="0.16689988945657733"/>
          <c:w val="0.52509733158355199"/>
          <c:h val="0.598020117802990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Ergothioneine'!$T$53:$T$57</c:f>
                <c:numCache>
                  <c:formatCode>General</c:formatCode>
                  <c:ptCount val="5"/>
                  <c:pt idx="0">
                    <c:v>6.3828763999999998</c:v>
                  </c:pt>
                  <c:pt idx="1">
                    <c:v>9.2482430999999998</c:v>
                  </c:pt>
                  <c:pt idx="2">
                    <c:v>6.6968483000000001</c:v>
                  </c:pt>
                  <c:pt idx="3">
                    <c:v>4.4967889999999997</c:v>
                  </c:pt>
                  <c:pt idx="4">
                    <c:v>1.2875471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Ergothioneine'!$R$53:$R$57</c:f>
              <c:strCache>
                <c:ptCount val="5"/>
                <c:pt idx="0">
                  <c:v>S1EC</c:v>
                </c:pt>
                <c:pt idx="1">
                  <c:v>S1EC+ERT 4mM</c:v>
                </c:pt>
                <c:pt idx="2">
                  <c:v>S1EC+ERT 6mM</c:v>
                </c:pt>
                <c:pt idx="3">
                  <c:v>S1EC+ERT 8mM</c:v>
                </c:pt>
                <c:pt idx="4">
                  <c:v>Quinns</c:v>
                </c:pt>
              </c:strCache>
            </c:strRef>
          </c:cat>
          <c:val>
            <c:numRef>
              <c:f>'S1EC+Ergothioneine'!$S$53:$S$57</c:f>
              <c:numCache>
                <c:formatCode>General</c:formatCode>
                <c:ptCount val="5"/>
                <c:pt idx="0">
                  <c:v>27.533332999999999</c:v>
                </c:pt>
                <c:pt idx="1">
                  <c:v>27.8</c:v>
                </c:pt>
                <c:pt idx="2">
                  <c:v>26.666667</c:v>
                </c:pt>
                <c:pt idx="3">
                  <c:v>23.866667</c:v>
                </c:pt>
                <c:pt idx="4">
                  <c:v>19.3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66-6A46-A14E-8CB821D28C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440800"/>
        <c:axId val="1379478144"/>
      </c:barChart>
      <c:catAx>
        <c:axId val="1379440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478144"/>
        <c:crosses val="autoZero"/>
        <c:auto val="1"/>
        <c:lblAlgn val="ctr"/>
        <c:lblOffset val="100"/>
        <c:noMultiLvlLbl val="0"/>
      </c:catAx>
      <c:valAx>
        <c:axId val="1379478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440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63648293963257"/>
          <c:y val="9.8408621525090847E-2"/>
          <c:w val="0.52103018372703402"/>
          <c:h val="0.701105895942052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Cyrene'!$N$42:$N$44</c:f>
                <c:numCache>
                  <c:formatCode>General</c:formatCode>
                  <c:ptCount val="3"/>
                  <c:pt idx="0">
                    <c:v>3.7013511000000001</c:v>
                  </c:pt>
                  <c:pt idx="1">
                    <c:v>4.0447496999999997</c:v>
                  </c:pt>
                  <c:pt idx="2">
                    <c:v>3.1048349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Cyrene'!$L$42:$L$44</c:f>
              <c:strCache>
                <c:ptCount val="3"/>
                <c:pt idx="0">
                  <c:v>Cyrene</c:v>
                </c:pt>
                <c:pt idx="1">
                  <c:v>DMSO</c:v>
                </c:pt>
                <c:pt idx="2">
                  <c:v>Quinns</c:v>
                </c:pt>
              </c:strCache>
            </c:strRef>
          </c:cat>
          <c:val>
            <c:numRef>
              <c:f>'S1EC+Cyrene'!$M$42:$M$44</c:f>
              <c:numCache>
                <c:formatCode>General</c:formatCode>
                <c:ptCount val="3"/>
                <c:pt idx="0">
                  <c:v>29</c:v>
                </c:pt>
                <c:pt idx="1">
                  <c:v>22.6</c:v>
                </c:pt>
                <c:pt idx="2">
                  <c:v>3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66-B04C-9872-395B981D96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1387968"/>
        <c:axId val="1811389680"/>
      </c:barChart>
      <c:catAx>
        <c:axId val="1811387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389680"/>
        <c:crosses val="autoZero"/>
        <c:auto val="1"/>
        <c:lblAlgn val="ctr"/>
        <c:lblOffset val="100"/>
        <c:noMultiLvlLbl val="0"/>
      </c:catAx>
      <c:valAx>
        <c:axId val="1811389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387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9687600806085377"/>
          <c:y val="0.14432283493283873"/>
          <c:w val="0.45498983788612735"/>
          <c:h val="0.717670072872328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Cyrene'!$K$42:$K$44</c:f>
                <c:numCache>
                  <c:formatCode>General</c:formatCode>
                  <c:ptCount val="3"/>
                  <c:pt idx="0">
                    <c:v>3.2771938999999999</c:v>
                  </c:pt>
                  <c:pt idx="1">
                    <c:v>3.0430248</c:v>
                  </c:pt>
                  <c:pt idx="2">
                    <c:v>3.4146741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Cyrene'!$I$42:$I$44</c:f>
              <c:strCache>
                <c:ptCount val="3"/>
                <c:pt idx="0">
                  <c:v>Cyrene</c:v>
                </c:pt>
                <c:pt idx="1">
                  <c:v>DMSO</c:v>
                </c:pt>
                <c:pt idx="2">
                  <c:v>Quinns</c:v>
                </c:pt>
              </c:strCache>
            </c:strRef>
          </c:cat>
          <c:val>
            <c:numRef>
              <c:f>'S1EC+Cyrene'!$J$42:$J$44</c:f>
              <c:numCache>
                <c:formatCode>General</c:formatCode>
                <c:ptCount val="3"/>
                <c:pt idx="0">
                  <c:v>49.2</c:v>
                </c:pt>
                <c:pt idx="1">
                  <c:v>50.4</c:v>
                </c:pt>
                <c:pt idx="2">
                  <c:v>46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42-484D-BEEA-9400F3A904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699072"/>
        <c:axId val="1379700784"/>
      </c:barChart>
      <c:catAx>
        <c:axId val="1379699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700784"/>
        <c:crosses val="autoZero"/>
        <c:auto val="1"/>
        <c:lblAlgn val="ctr"/>
        <c:lblOffset val="100"/>
        <c:noMultiLvlLbl val="0"/>
      </c:catAx>
      <c:valAx>
        <c:axId val="13797007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69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119203849518811"/>
          <c:y val="0.15118844553638122"/>
          <c:w val="0.52103018372703402"/>
          <c:h val="0.694250095309137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Cyrene'!$H$42:$H$44</c:f>
                <c:numCache>
                  <c:formatCode>General</c:formatCode>
                  <c:ptCount val="3"/>
                  <c:pt idx="0">
                    <c:v>1.3241601000000001</c:v>
                  </c:pt>
                  <c:pt idx="1">
                    <c:v>2.0520721000000002</c:v>
                  </c:pt>
                  <c:pt idx="2">
                    <c:v>1.3178011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Cyrene'!$F$42:$F$44</c:f>
              <c:strCache>
                <c:ptCount val="3"/>
                <c:pt idx="0">
                  <c:v>Cyrene</c:v>
                </c:pt>
                <c:pt idx="1">
                  <c:v>DMSO</c:v>
                </c:pt>
                <c:pt idx="2">
                  <c:v>Quinns</c:v>
                </c:pt>
              </c:strCache>
            </c:strRef>
          </c:cat>
          <c:val>
            <c:numRef>
              <c:f>'S1EC+Cyrene'!$G$42:$G$44</c:f>
              <c:numCache>
                <c:formatCode>General</c:formatCode>
                <c:ptCount val="3"/>
                <c:pt idx="0">
                  <c:v>5.92</c:v>
                </c:pt>
                <c:pt idx="1">
                  <c:v>7.9</c:v>
                </c:pt>
                <c:pt idx="2">
                  <c:v>8.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B6-ED4E-B06B-067DA424A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9228240"/>
        <c:axId val="439182256"/>
      </c:barChart>
      <c:catAx>
        <c:axId val="439228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182256"/>
        <c:crosses val="autoZero"/>
        <c:auto val="1"/>
        <c:lblAlgn val="ctr"/>
        <c:lblOffset val="100"/>
        <c:noMultiLvlLbl val="0"/>
      </c:catAx>
      <c:valAx>
        <c:axId val="439182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228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0322944461558829"/>
          <c:y val="0.13345310959674728"/>
          <c:w val="0.43775101141107015"/>
          <c:h val="0.664448394628249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Cyrene'!$E$42:$E$44</c:f>
                <c:numCache>
                  <c:formatCode>General</c:formatCode>
                  <c:ptCount val="3"/>
                  <c:pt idx="0">
                    <c:v>2.2229260000000002</c:v>
                  </c:pt>
                  <c:pt idx="1">
                    <c:v>1.907459</c:v>
                  </c:pt>
                  <c:pt idx="2">
                    <c:v>1.43443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Cyrene'!$C$42:$C$44</c:f>
              <c:strCache>
                <c:ptCount val="3"/>
                <c:pt idx="0">
                  <c:v>Cyrene</c:v>
                </c:pt>
                <c:pt idx="1">
                  <c:v>DMSO</c:v>
                </c:pt>
                <c:pt idx="2">
                  <c:v>Quinns</c:v>
                </c:pt>
              </c:strCache>
            </c:strRef>
          </c:cat>
          <c:val>
            <c:numRef>
              <c:f>'S1EC+Cyrene'!$D$42:$D$44</c:f>
              <c:numCache>
                <c:formatCode>General</c:formatCode>
                <c:ptCount val="3"/>
                <c:pt idx="0">
                  <c:v>15.38</c:v>
                </c:pt>
                <c:pt idx="1">
                  <c:v>18.82</c:v>
                </c:pt>
                <c:pt idx="2">
                  <c:v>16.0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1C-F743-9475-C5A29FB5E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592992"/>
        <c:axId val="1379678208"/>
      </c:barChart>
      <c:catAx>
        <c:axId val="1379592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678208"/>
        <c:crosses val="autoZero"/>
        <c:auto val="1"/>
        <c:lblAlgn val="ctr"/>
        <c:lblOffset val="100"/>
        <c:noMultiLvlLbl val="0"/>
      </c:catAx>
      <c:valAx>
        <c:axId val="1379678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592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-Calcium'!$W$39:$W$42</c:f>
                <c:numCache>
                  <c:formatCode>General</c:formatCode>
                  <c:ptCount val="4"/>
                  <c:pt idx="0">
                    <c:v>3.7577387</c:v>
                  </c:pt>
                  <c:pt idx="1">
                    <c:v>1.8843036</c:v>
                  </c:pt>
                  <c:pt idx="2">
                    <c:v>2.4375396999999999</c:v>
                  </c:pt>
                  <c:pt idx="3">
                    <c:v>2.829947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-Calcium'!$U$39:$U$42</c:f>
              <c:strCache>
                <c:ptCount val="4"/>
                <c:pt idx="0">
                  <c:v>S1EC</c:v>
                </c:pt>
                <c:pt idx="1">
                  <c:v>S1EC 1/2 CaCl2</c:v>
                </c:pt>
                <c:pt idx="2">
                  <c:v>S1EC 1/4 CaCl2</c:v>
                </c:pt>
                <c:pt idx="3">
                  <c:v>Quinns</c:v>
                </c:pt>
              </c:strCache>
            </c:strRef>
          </c:cat>
          <c:val>
            <c:numRef>
              <c:f>'S1EC-Calcium'!$V$39:$V$42</c:f>
              <c:numCache>
                <c:formatCode>General</c:formatCode>
                <c:ptCount val="4"/>
                <c:pt idx="0">
                  <c:v>10.64</c:v>
                </c:pt>
                <c:pt idx="1">
                  <c:v>6.14</c:v>
                </c:pt>
                <c:pt idx="2">
                  <c:v>8.66</c:v>
                </c:pt>
                <c:pt idx="3">
                  <c:v>10.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44-0447-82EF-2384BE2ECB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242336"/>
        <c:axId val="1379244048"/>
      </c:barChart>
      <c:catAx>
        <c:axId val="1379242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244048"/>
        <c:crosses val="autoZero"/>
        <c:auto val="1"/>
        <c:lblAlgn val="ctr"/>
        <c:lblOffset val="100"/>
        <c:noMultiLvlLbl val="0"/>
      </c:catAx>
      <c:valAx>
        <c:axId val="1379244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242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-Calcium'!$Z$39:$Z$42</c:f>
                <c:numCache>
                  <c:formatCode>General</c:formatCode>
                  <c:ptCount val="4"/>
                  <c:pt idx="0">
                    <c:v>3.2465366000000002</c:v>
                  </c:pt>
                  <c:pt idx="1">
                    <c:v>3.544009</c:v>
                  </c:pt>
                  <c:pt idx="2">
                    <c:v>2.0880613000000001</c:v>
                  </c:pt>
                  <c:pt idx="3">
                    <c:v>2.78208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-Calcium'!$X$39:$X$42</c:f>
              <c:strCache>
                <c:ptCount val="4"/>
                <c:pt idx="0">
                  <c:v>S1EC</c:v>
                </c:pt>
                <c:pt idx="1">
                  <c:v>S1EC 1/2 CaCl2</c:v>
                </c:pt>
                <c:pt idx="2">
                  <c:v>S1EC 1/4 CaCl2</c:v>
                </c:pt>
                <c:pt idx="3">
                  <c:v>Quinns</c:v>
                </c:pt>
              </c:strCache>
            </c:strRef>
          </c:cat>
          <c:val>
            <c:numRef>
              <c:f>'S1EC-Calcium'!$Y$39:$Y$42</c:f>
              <c:numCache>
                <c:formatCode>General</c:formatCode>
                <c:ptCount val="4"/>
                <c:pt idx="0">
                  <c:v>53.8</c:v>
                </c:pt>
                <c:pt idx="1">
                  <c:v>43.6</c:v>
                </c:pt>
                <c:pt idx="2">
                  <c:v>43.6</c:v>
                </c:pt>
                <c:pt idx="3">
                  <c:v>46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39-FF49-8919-CB130F0DB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4355776"/>
        <c:axId val="1354357488"/>
      </c:barChart>
      <c:catAx>
        <c:axId val="1354355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54357488"/>
        <c:crosses val="autoZero"/>
        <c:auto val="1"/>
        <c:lblAlgn val="ctr"/>
        <c:lblOffset val="100"/>
        <c:noMultiLvlLbl val="0"/>
      </c:catAx>
      <c:valAx>
        <c:axId val="135435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54355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-Calcium'!$AC$39:$AC$42</c:f>
                <c:numCache>
                  <c:formatCode>General</c:formatCode>
                  <c:ptCount val="4"/>
                  <c:pt idx="0">
                    <c:v>3.1717502999999998</c:v>
                  </c:pt>
                  <c:pt idx="1">
                    <c:v>1.6552944999999999</c:v>
                  </c:pt>
                  <c:pt idx="2">
                    <c:v>1.1661904000000001</c:v>
                  </c:pt>
                  <c:pt idx="3">
                    <c:v>3.1304951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-Calcium'!$AA$39:$AA$42</c:f>
              <c:strCache>
                <c:ptCount val="4"/>
                <c:pt idx="0">
                  <c:v>S1EC</c:v>
                </c:pt>
                <c:pt idx="1">
                  <c:v>S1EC 1/2 CaCl2</c:v>
                </c:pt>
                <c:pt idx="2">
                  <c:v>S1EC 1/4 CaCl2</c:v>
                </c:pt>
                <c:pt idx="3">
                  <c:v>Quinns</c:v>
                </c:pt>
              </c:strCache>
            </c:strRef>
          </c:cat>
          <c:val>
            <c:numRef>
              <c:f>'S1EC-Calcium'!$AB$39:$AB$42</c:f>
              <c:numCache>
                <c:formatCode>General</c:formatCode>
                <c:ptCount val="4"/>
                <c:pt idx="0">
                  <c:v>25.6</c:v>
                </c:pt>
                <c:pt idx="1">
                  <c:v>35.799999999999997</c:v>
                </c:pt>
                <c:pt idx="2">
                  <c:v>32.6</c:v>
                </c:pt>
                <c:pt idx="3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45-C64E-8449-BAD96C6188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1116368"/>
        <c:axId val="1811118080"/>
      </c:barChart>
      <c:catAx>
        <c:axId val="1811116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1118080"/>
        <c:crosses val="autoZero"/>
        <c:auto val="1"/>
        <c:lblAlgn val="ctr"/>
        <c:lblOffset val="100"/>
        <c:noMultiLvlLbl val="0"/>
      </c:catAx>
      <c:valAx>
        <c:axId val="1811118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116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3031496062992"/>
          <c:y val="0.10179734958474439"/>
          <c:w val="0.52103018372703402"/>
          <c:h val="0.566565762391485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Zinc'!$V$37:$V$41</c:f>
                <c:numCache>
                  <c:formatCode>General</c:formatCode>
                  <c:ptCount val="5"/>
                  <c:pt idx="0">
                    <c:v>4.0648001000000002</c:v>
                  </c:pt>
                  <c:pt idx="1">
                    <c:v>3.2986361</c:v>
                  </c:pt>
                  <c:pt idx="2">
                    <c:v>2.9777507999999999</c:v>
                  </c:pt>
                  <c:pt idx="3">
                    <c:v>2.9964312</c:v>
                  </c:pt>
                  <c:pt idx="4">
                    <c:v>4.6523757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Zinc'!$T$37:$T$41</c:f>
              <c:strCache>
                <c:ptCount val="5"/>
                <c:pt idx="0">
                  <c:v>S1EC</c:v>
                </c:pt>
                <c:pt idx="1">
                  <c:v>S1EC+ZnSO4 25uM</c:v>
                </c:pt>
                <c:pt idx="2">
                  <c:v>S1EC+ZnSO4 50uM</c:v>
                </c:pt>
                <c:pt idx="3">
                  <c:v>S1EC+ZnSO4 100uM</c:v>
                </c:pt>
                <c:pt idx="4">
                  <c:v>Quinns</c:v>
                </c:pt>
              </c:strCache>
            </c:strRef>
          </c:cat>
          <c:val>
            <c:numRef>
              <c:f>'S1EC+Zinc'!$U$37:$U$41</c:f>
              <c:numCache>
                <c:formatCode>General</c:formatCode>
                <c:ptCount val="5"/>
                <c:pt idx="0">
                  <c:v>24.34</c:v>
                </c:pt>
                <c:pt idx="1">
                  <c:v>16.8</c:v>
                </c:pt>
                <c:pt idx="2">
                  <c:v>16.8</c:v>
                </c:pt>
                <c:pt idx="3">
                  <c:v>19.16</c:v>
                </c:pt>
                <c:pt idx="4">
                  <c:v>22.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4C-644E-9BDF-E9C0C927D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9008032"/>
        <c:axId val="439009744"/>
      </c:barChart>
      <c:catAx>
        <c:axId val="439008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9009744"/>
        <c:crosses val="autoZero"/>
        <c:auto val="1"/>
        <c:lblAlgn val="ctr"/>
        <c:lblOffset val="100"/>
        <c:noMultiLvlLbl val="0"/>
      </c:catAx>
      <c:valAx>
        <c:axId val="439009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008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08092738407699"/>
          <c:y val="0.11649175959163793"/>
          <c:w val="0.52103018372703402"/>
          <c:h val="0.584163310496355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Zinc'!$Y$37:$Y$41</c:f>
                <c:numCache>
                  <c:formatCode>General</c:formatCode>
                  <c:ptCount val="5"/>
                  <c:pt idx="0">
                    <c:v>3.3950551999999998</c:v>
                  </c:pt>
                  <c:pt idx="1">
                    <c:v>1.9997499999999999</c:v>
                  </c:pt>
                  <c:pt idx="2">
                    <c:v>1.7614198999999999</c:v>
                  </c:pt>
                  <c:pt idx="3">
                    <c:v>2.1848112</c:v>
                  </c:pt>
                  <c:pt idx="4">
                    <c:v>2.2931200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Zinc'!$W$37:$W$41</c:f>
              <c:strCache>
                <c:ptCount val="5"/>
                <c:pt idx="0">
                  <c:v>S1EC</c:v>
                </c:pt>
                <c:pt idx="1">
                  <c:v>S1EC+ZnSO4 25uM</c:v>
                </c:pt>
                <c:pt idx="2">
                  <c:v>S1EC+ZnSO4 50uM</c:v>
                </c:pt>
                <c:pt idx="3">
                  <c:v>S1EC+ZnSO4 100uM</c:v>
                </c:pt>
                <c:pt idx="4">
                  <c:v>Quinns</c:v>
                </c:pt>
              </c:strCache>
            </c:strRef>
          </c:cat>
          <c:val>
            <c:numRef>
              <c:f>'S1EC+Zinc'!$X$37:$X$41</c:f>
              <c:numCache>
                <c:formatCode>General</c:formatCode>
                <c:ptCount val="5"/>
                <c:pt idx="0">
                  <c:v>11.92</c:v>
                </c:pt>
                <c:pt idx="1">
                  <c:v>7.2</c:v>
                </c:pt>
                <c:pt idx="2">
                  <c:v>7.56</c:v>
                </c:pt>
                <c:pt idx="3">
                  <c:v>9.8800000000000008</c:v>
                </c:pt>
                <c:pt idx="4">
                  <c:v>9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39-2045-B0D2-58B847740B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9352816"/>
        <c:axId val="1379355616"/>
      </c:barChart>
      <c:catAx>
        <c:axId val="1379352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355616"/>
        <c:crosses val="autoZero"/>
        <c:auto val="1"/>
        <c:lblAlgn val="ctr"/>
        <c:lblOffset val="100"/>
        <c:noMultiLvlLbl val="0"/>
      </c:catAx>
      <c:valAx>
        <c:axId val="1379355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79352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41426071741033"/>
          <c:y val="0.15229015695342232"/>
          <c:w val="0.52380796150481179"/>
          <c:h val="0.603728609173091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Zinc'!$AB$37:$AB$41</c:f>
                <c:numCache>
                  <c:formatCode>General</c:formatCode>
                  <c:ptCount val="5"/>
                  <c:pt idx="0">
                    <c:v>2.1587033</c:v>
                  </c:pt>
                  <c:pt idx="1">
                    <c:v>2.9563491000000002</c:v>
                  </c:pt>
                  <c:pt idx="2">
                    <c:v>3.2341923000000001</c:v>
                  </c:pt>
                  <c:pt idx="3">
                    <c:v>1.933908</c:v>
                  </c:pt>
                  <c:pt idx="4">
                    <c:v>2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Zinc'!$Z$37:$Z$41</c:f>
              <c:strCache>
                <c:ptCount val="5"/>
                <c:pt idx="0">
                  <c:v>S1EC</c:v>
                </c:pt>
                <c:pt idx="1">
                  <c:v>S1EC+ZnSO4 25uM</c:v>
                </c:pt>
                <c:pt idx="2">
                  <c:v>S1EC+ZnSO4 50uM</c:v>
                </c:pt>
                <c:pt idx="3">
                  <c:v>S1EC+ZnSO4 100uM</c:v>
                </c:pt>
                <c:pt idx="4">
                  <c:v>Quinns</c:v>
                </c:pt>
              </c:strCache>
            </c:strRef>
          </c:cat>
          <c:val>
            <c:numRef>
              <c:f>'S1EC+Zinc'!$AA$37:$AA$41</c:f>
              <c:numCache>
                <c:formatCode>General</c:formatCode>
                <c:ptCount val="5"/>
                <c:pt idx="0">
                  <c:v>52.6</c:v>
                </c:pt>
                <c:pt idx="1">
                  <c:v>53.8</c:v>
                </c:pt>
                <c:pt idx="2">
                  <c:v>55.6</c:v>
                </c:pt>
                <c:pt idx="3">
                  <c:v>51.8</c:v>
                </c:pt>
                <c:pt idx="4">
                  <c:v>5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48-164A-A799-D5670F10F1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9090336"/>
        <c:axId val="439092048"/>
      </c:barChart>
      <c:catAx>
        <c:axId val="439090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9092048"/>
        <c:crosses val="autoZero"/>
        <c:auto val="1"/>
        <c:lblAlgn val="ctr"/>
        <c:lblOffset val="100"/>
        <c:noMultiLvlLbl val="0"/>
      </c:catAx>
      <c:valAx>
        <c:axId val="4390920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090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85870516185479"/>
          <c:y val="4.3770226495477363E-2"/>
          <c:w val="0.52380796150481179"/>
          <c:h val="0.7015488858886450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Zinc'!$AE$37:$AE$41</c:f>
                <c:numCache>
                  <c:formatCode>General</c:formatCode>
                  <c:ptCount val="5"/>
                  <c:pt idx="0">
                    <c:v>2.6532998000000001</c:v>
                  </c:pt>
                  <c:pt idx="1">
                    <c:v>2.1817424000000001</c:v>
                  </c:pt>
                  <c:pt idx="2">
                    <c:v>2.2135943999999999</c:v>
                  </c:pt>
                  <c:pt idx="3">
                    <c:v>3.8131352000000001</c:v>
                  </c:pt>
                  <c:pt idx="4">
                    <c:v>2.2494443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Zinc'!$AC$37:$AC$41</c:f>
              <c:strCache>
                <c:ptCount val="5"/>
                <c:pt idx="0">
                  <c:v>S1EC</c:v>
                </c:pt>
                <c:pt idx="1">
                  <c:v>S1EC+ZnSO4 25uM</c:v>
                </c:pt>
                <c:pt idx="2">
                  <c:v>S1EC+ZnSO4 50uM</c:v>
                </c:pt>
                <c:pt idx="3">
                  <c:v>S1EC+ZnSO4 100uM</c:v>
                </c:pt>
                <c:pt idx="4">
                  <c:v>Quinns</c:v>
                </c:pt>
              </c:strCache>
            </c:strRef>
          </c:cat>
          <c:val>
            <c:numRef>
              <c:f>'S1EC+Zinc'!$AD$37:$AD$41</c:f>
              <c:numCache>
                <c:formatCode>General</c:formatCode>
                <c:ptCount val="5"/>
                <c:pt idx="0">
                  <c:v>19.2</c:v>
                </c:pt>
                <c:pt idx="1">
                  <c:v>24.6</c:v>
                </c:pt>
                <c:pt idx="2">
                  <c:v>25</c:v>
                </c:pt>
                <c:pt idx="3">
                  <c:v>30.2</c:v>
                </c:pt>
                <c:pt idx="4">
                  <c:v>2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F6-6E42-8B77-E9A34A6578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4270704"/>
        <c:axId val="1354416992"/>
      </c:barChart>
      <c:catAx>
        <c:axId val="1354270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54416992"/>
        <c:crosses val="autoZero"/>
        <c:auto val="1"/>
        <c:lblAlgn val="ctr"/>
        <c:lblOffset val="100"/>
        <c:noMultiLvlLbl val="0"/>
      </c:catAx>
      <c:valAx>
        <c:axId val="1354416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54270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08092738407699"/>
          <c:y val="9.563024361609615E-2"/>
          <c:w val="0.52103018372703402"/>
          <c:h val="0.6790534504237456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1EC+Ergothioneine'!$Z$53:$Z$57</c:f>
                <c:numCache>
                  <c:formatCode>General</c:formatCode>
                  <c:ptCount val="5"/>
                  <c:pt idx="0">
                    <c:v>2.5166114999999998</c:v>
                  </c:pt>
                  <c:pt idx="1">
                    <c:v>2.3333333000000001</c:v>
                  </c:pt>
                  <c:pt idx="2">
                    <c:v>0.88191710000000001</c:v>
                  </c:pt>
                  <c:pt idx="3">
                    <c:v>2.3333333000000001</c:v>
                  </c:pt>
                  <c:pt idx="4">
                    <c:v>6.0827625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1EC+Ergothioneine'!$X$53:$X$57</c:f>
              <c:strCache>
                <c:ptCount val="5"/>
                <c:pt idx="0">
                  <c:v>S1EC</c:v>
                </c:pt>
                <c:pt idx="1">
                  <c:v>S1EC+ERT 4mM</c:v>
                </c:pt>
                <c:pt idx="2">
                  <c:v>S1EC+ERT 6mM</c:v>
                </c:pt>
                <c:pt idx="3">
                  <c:v>S1EC+ERT 8mM</c:v>
                </c:pt>
                <c:pt idx="4">
                  <c:v>Quinns</c:v>
                </c:pt>
              </c:strCache>
            </c:strRef>
          </c:cat>
          <c:val>
            <c:numRef>
              <c:f>'S1EC+Ergothioneine'!$Y$53:$Y$57</c:f>
              <c:numCache>
                <c:formatCode>General</c:formatCode>
                <c:ptCount val="5"/>
                <c:pt idx="0">
                  <c:v>51</c:v>
                </c:pt>
                <c:pt idx="1">
                  <c:v>47.666666999999997</c:v>
                </c:pt>
                <c:pt idx="2">
                  <c:v>53.666666999999997</c:v>
                </c:pt>
                <c:pt idx="3">
                  <c:v>53.333333000000003</c:v>
                </c:pt>
                <c:pt idx="4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35-BF49-BF36-D01781D3B5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1109088"/>
        <c:axId val="1811110800"/>
      </c:barChart>
      <c:catAx>
        <c:axId val="1811109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1110800"/>
        <c:crosses val="autoZero"/>
        <c:auto val="1"/>
        <c:lblAlgn val="ctr"/>
        <c:lblOffset val="100"/>
        <c:noMultiLvlLbl val="0"/>
      </c:catAx>
      <c:valAx>
        <c:axId val="1811110800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109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330246-C24F-7F4C-9BF9-2288321C397B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769A98-A6AC-7147-B6BD-ABFFCD206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077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9688F5-13DC-5B4F-85AB-1063A13BA83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1572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426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37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84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27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934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840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261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45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85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123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349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2BAA35-C620-8242-B545-FC2761D1723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1C60A2-0393-7D43-B8D6-D029DB879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840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07B20-ECAD-5FBB-941E-E42D21E15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42975" y="202832"/>
            <a:ext cx="5915025" cy="1914702"/>
          </a:xfrm>
        </p:spPr>
        <p:txBody>
          <a:bodyPr/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s </a:t>
            </a:r>
          </a:p>
        </p:txBody>
      </p:sp>
    </p:spTree>
    <p:extLst>
      <p:ext uri="{BB962C8B-B14F-4D97-AF65-F5344CB8AC3E}">
        <p14:creationId xmlns:p14="http://schemas.microsoft.com/office/powerpoint/2010/main" val="5903482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40557B5-BF97-1EA4-3158-5E38D37DBA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4273435"/>
              </p:ext>
            </p:extLst>
          </p:nvPr>
        </p:nvGraphicFramePr>
        <p:xfrm>
          <a:off x="678622" y="699637"/>
          <a:ext cx="2817198" cy="3297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C3FF859-E41D-5C3B-7A61-D761A8433E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4148567"/>
              </p:ext>
            </p:extLst>
          </p:nvPr>
        </p:nvGraphicFramePr>
        <p:xfrm>
          <a:off x="3842022" y="692820"/>
          <a:ext cx="2817198" cy="3297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2626D61-72D4-F8F5-192C-947FACFB21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7325262"/>
              </p:ext>
            </p:extLst>
          </p:nvPr>
        </p:nvGraphicFramePr>
        <p:xfrm>
          <a:off x="698524" y="4862092"/>
          <a:ext cx="2817198" cy="3297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882C943B-7667-085B-EC90-3048ABBC5E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7346627"/>
              </p:ext>
            </p:extLst>
          </p:nvPr>
        </p:nvGraphicFramePr>
        <p:xfrm>
          <a:off x="3852805" y="4864359"/>
          <a:ext cx="2817198" cy="3297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85F609E7-188D-88BA-0FC5-EC514979C3D0}"/>
              </a:ext>
            </a:extLst>
          </p:cNvPr>
          <p:cNvGrpSpPr/>
          <p:nvPr/>
        </p:nvGrpSpPr>
        <p:grpSpPr>
          <a:xfrm>
            <a:off x="957745" y="3617753"/>
            <a:ext cx="2291012" cy="674494"/>
            <a:chOff x="1156525" y="3617753"/>
            <a:chExt cx="2291012" cy="674494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226A82D-B4FB-2095-5315-870CFDD410E5}"/>
                </a:ext>
              </a:extLst>
            </p:cNvPr>
            <p:cNvSpPr txBox="1"/>
            <p:nvPr/>
          </p:nvSpPr>
          <p:spPr>
            <a:xfrm>
              <a:off x="1310527" y="3779577"/>
              <a:ext cx="17556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7            0.85          0.425     </a:t>
              </a:r>
            </a:p>
          </p:txBody>
        </p:sp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id="{DFA3FD61-2E61-F3D5-9065-5C4B954D242B}"/>
                </a:ext>
              </a:extLst>
            </p:cNvPr>
            <p:cNvSpPr/>
            <p:nvPr/>
          </p:nvSpPr>
          <p:spPr>
            <a:xfrm rot="5400000">
              <a:off x="2041796" y="3333912"/>
              <a:ext cx="36000" cy="1404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A4DDA09-81A0-8D12-9B72-128762D968F9}"/>
                </a:ext>
              </a:extLst>
            </p:cNvPr>
            <p:cNvSpPr txBox="1"/>
            <p:nvPr/>
          </p:nvSpPr>
          <p:spPr>
            <a:xfrm>
              <a:off x="1638786" y="4061415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alcium (mM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2734305-ACE9-C4D0-FFD3-ACA84F454944}"/>
                </a:ext>
              </a:extLst>
            </p:cNvPr>
            <p:cNvSpPr txBox="1"/>
            <p:nvPr/>
          </p:nvSpPr>
          <p:spPr>
            <a:xfrm>
              <a:off x="1156525" y="3617753"/>
              <a:ext cx="2291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CCM+EC    CCM+EC          Q 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DE3092C-78F2-30B2-AB6B-CE5BD2D5D323}"/>
              </a:ext>
            </a:extLst>
          </p:cNvPr>
          <p:cNvSpPr txBox="1"/>
          <p:nvPr/>
        </p:nvSpPr>
        <p:spPr>
          <a:xfrm rot="16200000">
            <a:off x="51343" y="1737809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tility (%)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148E14F-8E7A-72AD-F4C0-2E27786A103E}"/>
              </a:ext>
            </a:extLst>
          </p:cNvPr>
          <p:cNvGrpSpPr/>
          <p:nvPr/>
        </p:nvGrpSpPr>
        <p:grpSpPr>
          <a:xfrm>
            <a:off x="4105115" y="3617753"/>
            <a:ext cx="2291012" cy="674494"/>
            <a:chOff x="1156525" y="3617753"/>
            <a:chExt cx="2291012" cy="67449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6081008-DDAC-3ECE-A7EE-1B4913A13D88}"/>
                </a:ext>
              </a:extLst>
            </p:cNvPr>
            <p:cNvSpPr txBox="1"/>
            <p:nvPr/>
          </p:nvSpPr>
          <p:spPr>
            <a:xfrm>
              <a:off x="1310527" y="3779577"/>
              <a:ext cx="17556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7            0.85          0.425     </a:t>
              </a:r>
            </a:p>
          </p:txBody>
        </p:sp>
        <p:sp>
          <p:nvSpPr>
            <p:cNvPr id="17" name="Left Bracket 16">
              <a:extLst>
                <a:ext uri="{FF2B5EF4-FFF2-40B4-BE49-F238E27FC236}">
                  <a16:creationId xmlns:a16="http://schemas.microsoft.com/office/drawing/2014/main" id="{39F0AA2A-594E-9E76-69F0-511C6AFCF057}"/>
                </a:ext>
              </a:extLst>
            </p:cNvPr>
            <p:cNvSpPr/>
            <p:nvPr/>
          </p:nvSpPr>
          <p:spPr>
            <a:xfrm rot="5400000">
              <a:off x="2041796" y="3333912"/>
              <a:ext cx="36000" cy="1404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943CCB-8FA8-F15E-CE07-AE2A755137EA}"/>
                </a:ext>
              </a:extLst>
            </p:cNvPr>
            <p:cNvSpPr txBox="1"/>
            <p:nvPr/>
          </p:nvSpPr>
          <p:spPr>
            <a:xfrm>
              <a:off x="1638786" y="4061415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alcium (mM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2B37E84-83AC-6141-68A8-6E07228C6E53}"/>
                </a:ext>
              </a:extLst>
            </p:cNvPr>
            <p:cNvSpPr txBox="1"/>
            <p:nvPr/>
          </p:nvSpPr>
          <p:spPr>
            <a:xfrm>
              <a:off x="1156525" y="3617753"/>
              <a:ext cx="2291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CCM+EC    CCM+EC          Q 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D792598-CEBE-234D-6900-1EEFEC10B6D8}"/>
              </a:ext>
            </a:extLst>
          </p:cNvPr>
          <p:cNvSpPr txBox="1"/>
          <p:nvPr/>
        </p:nvSpPr>
        <p:spPr>
          <a:xfrm rot="16200000">
            <a:off x="2776794" y="1955059"/>
            <a:ext cx="1797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gressive motility (%)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450C025-0C02-2C68-0123-6CF7B529ABFA}"/>
              </a:ext>
            </a:extLst>
          </p:cNvPr>
          <p:cNvGrpSpPr/>
          <p:nvPr/>
        </p:nvGrpSpPr>
        <p:grpSpPr>
          <a:xfrm>
            <a:off x="971556" y="7785562"/>
            <a:ext cx="2291012" cy="674494"/>
            <a:chOff x="1156525" y="3617753"/>
            <a:chExt cx="2291012" cy="67449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AB02FE8-E3DB-3826-DBB8-13616F534247}"/>
                </a:ext>
              </a:extLst>
            </p:cNvPr>
            <p:cNvSpPr txBox="1"/>
            <p:nvPr/>
          </p:nvSpPr>
          <p:spPr>
            <a:xfrm>
              <a:off x="1310527" y="3779577"/>
              <a:ext cx="17556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7            0.85          0.425     </a:t>
              </a:r>
            </a:p>
          </p:txBody>
        </p:sp>
        <p:sp>
          <p:nvSpPr>
            <p:cNvPr id="23" name="Left Bracket 22">
              <a:extLst>
                <a:ext uri="{FF2B5EF4-FFF2-40B4-BE49-F238E27FC236}">
                  <a16:creationId xmlns:a16="http://schemas.microsoft.com/office/drawing/2014/main" id="{BD72A23F-AE54-22B5-BC84-E8241312E6AA}"/>
                </a:ext>
              </a:extLst>
            </p:cNvPr>
            <p:cNvSpPr/>
            <p:nvPr/>
          </p:nvSpPr>
          <p:spPr>
            <a:xfrm rot="5400000">
              <a:off x="2041796" y="3333912"/>
              <a:ext cx="36000" cy="1404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266D1C2-F0CB-99DE-DD4C-67643EBC198A}"/>
                </a:ext>
              </a:extLst>
            </p:cNvPr>
            <p:cNvSpPr txBox="1"/>
            <p:nvPr/>
          </p:nvSpPr>
          <p:spPr>
            <a:xfrm>
              <a:off x="1638786" y="4061415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alcium (mM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34ECBE6-C590-44E1-6B3A-F44D365C4729}"/>
                </a:ext>
              </a:extLst>
            </p:cNvPr>
            <p:cNvSpPr txBox="1"/>
            <p:nvPr/>
          </p:nvSpPr>
          <p:spPr>
            <a:xfrm>
              <a:off x="1156525" y="3617753"/>
              <a:ext cx="2291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CCM+EC    CCM+EC          Q 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FC2F9A2F-510A-9F17-B2AA-1F46D2411447}"/>
              </a:ext>
            </a:extLst>
          </p:cNvPr>
          <p:cNvSpPr txBox="1"/>
          <p:nvPr/>
        </p:nvSpPr>
        <p:spPr>
          <a:xfrm rot="16200000">
            <a:off x="42830" y="6012094"/>
            <a:ext cx="959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tality  (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897482B-3D09-4213-6704-19846B006279}"/>
              </a:ext>
            </a:extLst>
          </p:cNvPr>
          <p:cNvSpPr txBox="1"/>
          <p:nvPr/>
        </p:nvSpPr>
        <p:spPr>
          <a:xfrm rot="16200000">
            <a:off x="2964569" y="5933121"/>
            <a:ext cx="1421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 damage  (%)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039E752A-36C8-79AF-E144-3D3307C54B17}"/>
              </a:ext>
            </a:extLst>
          </p:cNvPr>
          <p:cNvGrpSpPr/>
          <p:nvPr/>
        </p:nvGrpSpPr>
        <p:grpSpPr>
          <a:xfrm>
            <a:off x="4174378" y="7778537"/>
            <a:ext cx="2291012" cy="674494"/>
            <a:chOff x="1156525" y="3617753"/>
            <a:chExt cx="2291012" cy="674494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2817417-5677-16EE-D32A-3D75AE0604F8}"/>
                </a:ext>
              </a:extLst>
            </p:cNvPr>
            <p:cNvSpPr txBox="1"/>
            <p:nvPr/>
          </p:nvSpPr>
          <p:spPr>
            <a:xfrm>
              <a:off x="1310527" y="3779577"/>
              <a:ext cx="17556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7            0.85          0.425     </a:t>
              </a:r>
            </a:p>
          </p:txBody>
        </p:sp>
        <p:sp>
          <p:nvSpPr>
            <p:cNvPr id="30" name="Left Bracket 29">
              <a:extLst>
                <a:ext uri="{FF2B5EF4-FFF2-40B4-BE49-F238E27FC236}">
                  <a16:creationId xmlns:a16="http://schemas.microsoft.com/office/drawing/2014/main" id="{96B5B133-EC90-894B-7720-CBC8E3C04DAA}"/>
                </a:ext>
              </a:extLst>
            </p:cNvPr>
            <p:cNvSpPr/>
            <p:nvPr/>
          </p:nvSpPr>
          <p:spPr>
            <a:xfrm rot="5400000">
              <a:off x="2041796" y="3333912"/>
              <a:ext cx="36000" cy="1404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C18C157-0129-0AFA-3054-2DCF0F8D0AD5}"/>
                </a:ext>
              </a:extLst>
            </p:cNvPr>
            <p:cNvSpPr txBox="1"/>
            <p:nvPr/>
          </p:nvSpPr>
          <p:spPr>
            <a:xfrm>
              <a:off x="1638786" y="4061415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alcium (mM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32B0C35-E600-4FF0-83C6-6B1A64BE2D31}"/>
                </a:ext>
              </a:extLst>
            </p:cNvPr>
            <p:cNvSpPr txBox="1"/>
            <p:nvPr/>
          </p:nvSpPr>
          <p:spPr>
            <a:xfrm>
              <a:off x="1156525" y="3617753"/>
              <a:ext cx="2291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CCM+EC    CCM+EC          Q 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5AC2A75-FA35-E4A2-CD3B-6F15CE0D01CF}"/>
              </a:ext>
            </a:extLst>
          </p:cNvPr>
          <p:cNvGrpSpPr/>
          <p:nvPr/>
        </p:nvGrpSpPr>
        <p:grpSpPr>
          <a:xfrm>
            <a:off x="847609" y="532366"/>
            <a:ext cx="5046204" cy="307777"/>
            <a:chOff x="847609" y="532366"/>
            <a:chExt cx="5046204" cy="307777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08F1655-E293-176F-33CB-27A6532F2E31}"/>
                </a:ext>
              </a:extLst>
            </p:cNvPr>
            <p:cNvSpPr txBox="1"/>
            <p:nvPr/>
          </p:nvSpPr>
          <p:spPr>
            <a:xfrm>
              <a:off x="847609" y="532366"/>
              <a:ext cx="9300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tility 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FB62F11-6C39-877E-B079-89686E543977}"/>
                </a:ext>
              </a:extLst>
            </p:cNvPr>
            <p:cNvSpPr txBox="1"/>
            <p:nvPr/>
          </p:nvSpPr>
          <p:spPr>
            <a:xfrm>
              <a:off x="4011566" y="532366"/>
              <a:ext cx="18822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ve  Motilit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7ECDDED5-8534-B956-AF7F-6895AAAAB864}"/>
              </a:ext>
            </a:extLst>
          </p:cNvPr>
          <p:cNvGrpSpPr/>
          <p:nvPr/>
        </p:nvGrpSpPr>
        <p:grpSpPr>
          <a:xfrm>
            <a:off x="1013835" y="4660656"/>
            <a:ext cx="4546067" cy="307777"/>
            <a:chOff x="847609" y="532366"/>
            <a:chExt cx="4546067" cy="307777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C796AB1-DDDE-C8C8-D224-D07A43ADFF63}"/>
                </a:ext>
              </a:extLst>
            </p:cNvPr>
            <p:cNvSpPr txBox="1"/>
            <p:nvPr/>
          </p:nvSpPr>
          <p:spPr>
            <a:xfrm>
              <a:off x="847609" y="532366"/>
              <a:ext cx="991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Vitality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DB502F3-85F8-B151-9B47-F3265353C86E}"/>
                </a:ext>
              </a:extLst>
            </p:cNvPr>
            <p:cNvSpPr txBox="1"/>
            <p:nvPr/>
          </p:nvSpPr>
          <p:spPr>
            <a:xfrm>
              <a:off x="4011566" y="532366"/>
              <a:ext cx="1382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 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NA damage 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24C9A1E8-829F-7ECE-9126-76AB98D42C6F}"/>
              </a:ext>
            </a:extLst>
          </p:cNvPr>
          <p:cNvSpPr txBox="1"/>
          <p:nvPr/>
        </p:nvSpPr>
        <p:spPr>
          <a:xfrm>
            <a:off x="5141667" y="40846"/>
            <a:ext cx="1640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8206088-9C31-83DD-2DBE-06A9EEAF726B}"/>
              </a:ext>
            </a:extLst>
          </p:cNvPr>
          <p:cNvSpPr txBox="1"/>
          <p:nvPr/>
        </p:nvSpPr>
        <p:spPr>
          <a:xfrm>
            <a:off x="4860523" y="49180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C32938B-13D7-EC27-D393-73E0DC90BB4D}"/>
              </a:ext>
            </a:extLst>
          </p:cNvPr>
          <p:cNvSpPr txBox="1"/>
          <p:nvPr/>
        </p:nvSpPr>
        <p:spPr>
          <a:xfrm>
            <a:off x="6101994" y="4914900"/>
            <a:ext cx="1477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726675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7A52996-E297-F013-2E65-E75065061E04}"/>
              </a:ext>
            </a:extLst>
          </p:cNvPr>
          <p:cNvGraphicFramePr>
            <a:graphicFrameLocks/>
          </p:cNvGraphicFramePr>
          <p:nvPr/>
        </p:nvGraphicFramePr>
        <p:xfrm>
          <a:off x="0" y="344557"/>
          <a:ext cx="4572000" cy="4797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DC413BF-0E7E-FD40-9B49-83BE4EEA9106}"/>
              </a:ext>
            </a:extLst>
          </p:cNvPr>
          <p:cNvGraphicFramePr>
            <a:graphicFrameLocks/>
          </p:cNvGraphicFramePr>
          <p:nvPr/>
        </p:nvGraphicFramePr>
        <p:xfrm>
          <a:off x="2999573" y="292430"/>
          <a:ext cx="4572000" cy="4660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E0F7C1D-7ED0-FB5B-F622-0EA5F0DE102C}"/>
              </a:ext>
            </a:extLst>
          </p:cNvPr>
          <p:cNvGraphicFramePr>
            <a:graphicFrameLocks/>
          </p:cNvGraphicFramePr>
          <p:nvPr/>
        </p:nvGraphicFramePr>
        <p:xfrm>
          <a:off x="62428" y="4302777"/>
          <a:ext cx="4572000" cy="44929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27CA3FF7-5F52-D2C2-5404-83F3408AA3BA}"/>
              </a:ext>
            </a:extLst>
          </p:cNvPr>
          <p:cNvGraphicFramePr>
            <a:graphicFrameLocks/>
          </p:cNvGraphicFramePr>
          <p:nvPr/>
        </p:nvGraphicFramePr>
        <p:xfrm>
          <a:off x="3133966" y="4798363"/>
          <a:ext cx="4572000" cy="3876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6FC90A2-FF8B-CD71-E383-F53BCC0D0C7F}"/>
              </a:ext>
            </a:extLst>
          </p:cNvPr>
          <p:cNvSpPr txBox="1"/>
          <p:nvPr/>
        </p:nvSpPr>
        <p:spPr>
          <a:xfrm rot="16200000">
            <a:off x="51343" y="1737809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tility (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3A9CED2-1403-5108-4C29-1FB307E2B4EA}"/>
              </a:ext>
            </a:extLst>
          </p:cNvPr>
          <p:cNvSpPr txBox="1"/>
          <p:nvPr/>
        </p:nvSpPr>
        <p:spPr>
          <a:xfrm rot="16200000">
            <a:off x="2719656" y="1955059"/>
            <a:ext cx="1797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gressive motility (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59A944-431A-81BD-8AD2-376B6603407F}"/>
              </a:ext>
            </a:extLst>
          </p:cNvPr>
          <p:cNvSpPr txBox="1"/>
          <p:nvPr/>
        </p:nvSpPr>
        <p:spPr>
          <a:xfrm rot="16200000">
            <a:off x="42830" y="6012094"/>
            <a:ext cx="959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tality 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3621EA9-AF49-9102-277E-9F4E55D1CFAB}"/>
              </a:ext>
            </a:extLst>
          </p:cNvPr>
          <p:cNvSpPr txBox="1"/>
          <p:nvPr/>
        </p:nvSpPr>
        <p:spPr>
          <a:xfrm rot="16200000">
            <a:off x="2907432" y="5933121"/>
            <a:ext cx="1421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 damage  (%)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24CEF61-A719-538B-774F-F9DA0EECD46C}"/>
              </a:ext>
            </a:extLst>
          </p:cNvPr>
          <p:cNvGrpSpPr/>
          <p:nvPr/>
        </p:nvGrpSpPr>
        <p:grpSpPr>
          <a:xfrm>
            <a:off x="847609" y="532366"/>
            <a:ext cx="5046204" cy="307777"/>
            <a:chOff x="847609" y="532366"/>
            <a:chExt cx="5046204" cy="30777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8C7F2E-A7EE-0582-0A7D-DBC92FA3C731}"/>
                </a:ext>
              </a:extLst>
            </p:cNvPr>
            <p:cNvSpPr txBox="1"/>
            <p:nvPr/>
          </p:nvSpPr>
          <p:spPr>
            <a:xfrm>
              <a:off x="847609" y="532366"/>
              <a:ext cx="9300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tility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AB5FCA3-9DC4-74BA-C7D9-706BAD91BF7E}"/>
                </a:ext>
              </a:extLst>
            </p:cNvPr>
            <p:cNvSpPr txBox="1"/>
            <p:nvPr/>
          </p:nvSpPr>
          <p:spPr>
            <a:xfrm>
              <a:off x="4011566" y="532366"/>
              <a:ext cx="18822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ve  Motilit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7E55440-4936-1EA5-E1D5-D49432F1AEC7}"/>
              </a:ext>
            </a:extLst>
          </p:cNvPr>
          <p:cNvGrpSpPr/>
          <p:nvPr/>
        </p:nvGrpSpPr>
        <p:grpSpPr>
          <a:xfrm>
            <a:off x="842852" y="4660656"/>
            <a:ext cx="4546067" cy="307777"/>
            <a:chOff x="847609" y="532366"/>
            <a:chExt cx="4546067" cy="307777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5AEF794-BA5F-110C-BC0C-2663FE5C078C}"/>
                </a:ext>
              </a:extLst>
            </p:cNvPr>
            <p:cNvSpPr txBox="1"/>
            <p:nvPr/>
          </p:nvSpPr>
          <p:spPr>
            <a:xfrm>
              <a:off x="847609" y="532366"/>
              <a:ext cx="991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Vitality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2E6040-5830-54DC-9E76-6ACB9D8FD225}"/>
                </a:ext>
              </a:extLst>
            </p:cNvPr>
            <p:cNvSpPr txBox="1"/>
            <p:nvPr/>
          </p:nvSpPr>
          <p:spPr>
            <a:xfrm>
              <a:off x="4011566" y="532366"/>
              <a:ext cx="1382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 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NA damage 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D04E118D-43FD-9A7E-6731-42C55556A156}"/>
              </a:ext>
            </a:extLst>
          </p:cNvPr>
          <p:cNvGrpSpPr/>
          <p:nvPr/>
        </p:nvGrpSpPr>
        <p:grpSpPr>
          <a:xfrm>
            <a:off x="866204" y="3584709"/>
            <a:ext cx="2400016" cy="508072"/>
            <a:chOff x="1156525" y="3617753"/>
            <a:chExt cx="2400016" cy="50807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3D240A9-0D5D-40E1-A920-11D0F73D7EC8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21" name="Left Bracket 20">
              <a:extLst>
                <a:ext uri="{FF2B5EF4-FFF2-40B4-BE49-F238E27FC236}">
                  <a16:creationId xmlns:a16="http://schemas.microsoft.com/office/drawing/2014/main" id="{92DB0015-88E9-B161-E18F-0CFA56178F0F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25FB89A-0DD8-AB90-4758-A3D6C3968900}"/>
                </a:ext>
              </a:extLst>
            </p:cNvPr>
            <p:cNvSpPr txBox="1"/>
            <p:nvPr/>
          </p:nvSpPr>
          <p:spPr>
            <a:xfrm>
              <a:off x="2089205" y="3894993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Zinc (µM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67E6AFA-1B5E-068F-D649-713458916F75}"/>
                </a:ext>
              </a:extLst>
            </p:cNvPr>
            <p:cNvSpPr txBox="1"/>
            <p:nvPr/>
          </p:nvSpPr>
          <p:spPr>
            <a:xfrm>
              <a:off x="1156525" y="3617753"/>
              <a:ext cx="24000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25           50         100           Q 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A29695A-C31C-5AB6-6E06-4E55F858F477}"/>
              </a:ext>
            </a:extLst>
          </p:cNvPr>
          <p:cNvGrpSpPr/>
          <p:nvPr/>
        </p:nvGrpSpPr>
        <p:grpSpPr>
          <a:xfrm>
            <a:off x="3984179" y="3576477"/>
            <a:ext cx="2400016" cy="508072"/>
            <a:chOff x="1156525" y="3617753"/>
            <a:chExt cx="2400016" cy="508072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14E54F7-7755-7449-2693-D02F2B30C46F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26" name="Left Bracket 25">
              <a:extLst>
                <a:ext uri="{FF2B5EF4-FFF2-40B4-BE49-F238E27FC236}">
                  <a16:creationId xmlns:a16="http://schemas.microsoft.com/office/drawing/2014/main" id="{B78B4918-28D3-32B5-AA27-D5151ED3EB05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060FD15-1716-7C8A-223A-13C99C97C2C2}"/>
                </a:ext>
              </a:extLst>
            </p:cNvPr>
            <p:cNvSpPr txBox="1"/>
            <p:nvPr/>
          </p:nvSpPr>
          <p:spPr>
            <a:xfrm>
              <a:off x="2089205" y="3894993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Zinc (µM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CB56A5C-B541-B532-D2D3-8A8244C93614}"/>
                </a:ext>
              </a:extLst>
            </p:cNvPr>
            <p:cNvSpPr txBox="1"/>
            <p:nvPr/>
          </p:nvSpPr>
          <p:spPr>
            <a:xfrm>
              <a:off x="1156525" y="3617753"/>
              <a:ext cx="24000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25           50         100           Q 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0B4EA60-DA8F-8A0F-C28F-A2A7D1C20A18}"/>
              </a:ext>
            </a:extLst>
          </p:cNvPr>
          <p:cNvGrpSpPr/>
          <p:nvPr/>
        </p:nvGrpSpPr>
        <p:grpSpPr>
          <a:xfrm>
            <a:off x="899375" y="7732999"/>
            <a:ext cx="2400016" cy="508072"/>
            <a:chOff x="1156525" y="3617753"/>
            <a:chExt cx="2400016" cy="508072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10FAC9B-4385-43D6-3FC4-9C5F8BCBF81C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31" name="Left Bracket 30">
              <a:extLst>
                <a:ext uri="{FF2B5EF4-FFF2-40B4-BE49-F238E27FC236}">
                  <a16:creationId xmlns:a16="http://schemas.microsoft.com/office/drawing/2014/main" id="{1A1E2488-0E28-8138-78AB-AE0CAA7F32B2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2A3C90A-3254-51D6-1644-2A9B2C8B317C}"/>
                </a:ext>
              </a:extLst>
            </p:cNvPr>
            <p:cNvSpPr txBox="1"/>
            <p:nvPr/>
          </p:nvSpPr>
          <p:spPr>
            <a:xfrm>
              <a:off x="2089205" y="3894993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Zinc (µM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F1D18FD-A738-7530-7052-EC87A9CB8241}"/>
                </a:ext>
              </a:extLst>
            </p:cNvPr>
            <p:cNvSpPr txBox="1"/>
            <p:nvPr/>
          </p:nvSpPr>
          <p:spPr>
            <a:xfrm>
              <a:off x="1156525" y="3617753"/>
              <a:ext cx="24000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25           50         100           Q 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526E7234-0BA4-D460-6102-BA55A5C4CBFD}"/>
              </a:ext>
            </a:extLst>
          </p:cNvPr>
          <p:cNvGrpSpPr/>
          <p:nvPr/>
        </p:nvGrpSpPr>
        <p:grpSpPr>
          <a:xfrm>
            <a:off x="4085536" y="7710376"/>
            <a:ext cx="2400016" cy="508072"/>
            <a:chOff x="1156525" y="3617753"/>
            <a:chExt cx="2400016" cy="508072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342A4D3-413C-A9E2-347C-F317693881B8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36" name="Left Bracket 35">
              <a:extLst>
                <a:ext uri="{FF2B5EF4-FFF2-40B4-BE49-F238E27FC236}">
                  <a16:creationId xmlns:a16="http://schemas.microsoft.com/office/drawing/2014/main" id="{8AB0EA36-6D89-EEBB-1D9F-15F13AB28D0F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B896181-2FAF-0587-4994-FE0B715BCE43}"/>
                </a:ext>
              </a:extLst>
            </p:cNvPr>
            <p:cNvSpPr txBox="1"/>
            <p:nvPr/>
          </p:nvSpPr>
          <p:spPr>
            <a:xfrm>
              <a:off x="2089205" y="3894993"/>
              <a:ext cx="10990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Zinc (µM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DA1934D-1ECE-1A42-F006-4DA286EC33BA}"/>
                </a:ext>
              </a:extLst>
            </p:cNvPr>
            <p:cNvSpPr txBox="1"/>
            <p:nvPr/>
          </p:nvSpPr>
          <p:spPr>
            <a:xfrm>
              <a:off x="1156525" y="3617753"/>
              <a:ext cx="24000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25           50         100           Q 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2F57BB7F-11FF-8454-E8DD-C8247B4D3BAA}"/>
              </a:ext>
            </a:extLst>
          </p:cNvPr>
          <p:cNvSpPr txBox="1"/>
          <p:nvPr/>
        </p:nvSpPr>
        <p:spPr>
          <a:xfrm>
            <a:off x="5067125" y="64701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3790243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C5A40DA6-2597-69C2-4E66-261CBE49F09E}"/>
              </a:ext>
            </a:extLst>
          </p:cNvPr>
          <p:cNvGraphicFramePr>
            <a:graphicFrameLocks/>
          </p:cNvGraphicFramePr>
          <p:nvPr/>
        </p:nvGraphicFramePr>
        <p:xfrm>
          <a:off x="-525673" y="5214229"/>
          <a:ext cx="4572000" cy="4040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2E038991-67F9-7036-B2BE-2000919EAE00}"/>
              </a:ext>
            </a:extLst>
          </p:cNvPr>
          <p:cNvGraphicFramePr>
            <a:graphicFrameLocks/>
          </p:cNvGraphicFramePr>
          <p:nvPr/>
        </p:nvGraphicFramePr>
        <p:xfrm>
          <a:off x="3203331" y="4977653"/>
          <a:ext cx="4572000" cy="43646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BC5E0768-7DAA-DFF9-9C6E-AEE205242923}"/>
              </a:ext>
            </a:extLst>
          </p:cNvPr>
          <p:cNvGraphicFramePr>
            <a:graphicFrameLocks/>
          </p:cNvGraphicFramePr>
          <p:nvPr/>
        </p:nvGraphicFramePr>
        <p:xfrm>
          <a:off x="2950949" y="1291918"/>
          <a:ext cx="4572000" cy="4040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19BCE54F-8EF2-9D90-37E1-92A28C79BA88}"/>
              </a:ext>
            </a:extLst>
          </p:cNvPr>
          <p:cNvGraphicFramePr>
            <a:graphicFrameLocks/>
          </p:cNvGraphicFramePr>
          <p:nvPr/>
        </p:nvGraphicFramePr>
        <p:xfrm>
          <a:off x="-525673" y="752424"/>
          <a:ext cx="4572000" cy="4545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6A5FEF5C-E663-F823-EAF3-695E44399B52}"/>
              </a:ext>
            </a:extLst>
          </p:cNvPr>
          <p:cNvSpPr txBox="1"/>
          <p:nvPr/>
        </p:nvSpPr>
        <p:spPr>
          <a:xfrm rot="16200000">
            <a:off x="-300796" y="2409937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tility (%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A92281-5437-D7A6-0BD5-48F82D905B8A}"/>
              </a:ext>
            </a:extLst>
          </p:cNvPr>
          <p:cNvSpPr txBox="1"/>
          <p:nvPr/>
        </p:nvSpPr>
        <p:spPr>
          <a:xfrm rot="16200000">
            <a:off x="2472702" y="2614293"/>
            <a:ext cx="1797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gressive motility (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4B398BD-DE50-089B-F59C-05B263FE5EA3}"/>
              </a:ext>
            </a:extLst>
          </p:cNvPr>
          <p:cNvSpPr txBox="1"/>
          <p:nvPr/>
        </p:nvSpPr>
        <p:spPr>
          <a:xfrm rot="16200000">
            <a:off x="-309309" y="6684222"/>
            <a:ext cx="959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tality  (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74AFA87-900A-97B6-E163-A672566CBC82}"/>
              </a:ext>
            </a:extLst>
          </p:cNvPr>
          <p:cNvSpPr txBox="1"/>
          <p:nvPr/>
        </p:nvSpPr>
        <p:spPr>
          <a:xfrm rot="16200000">
            <a:off x="2664939" y="6642329"/>
            <a:ext cx="1421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 damage  (%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5BE80A4-8DEF-3EC8-94CB-46E8783614C0}"/>
              </a:ext>
            </a:extLst>
          </p:cNvPr>
          <p:cNvGrpSpPr/>
          <p:nvPr/>
        </p:nvGrpSpPr>
        <p:grpSpPr>
          <a:xfrm>
            <a:off x="495470" y="1204494"/>
            <a:ext cx="5046204" cy="307777"/>
            <a:chOff x="847609" y="532366"/>
            <a:chExt cx="5046204" cy="307777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682A8D2-83F6-31EB-F4C5-96A5FD35B8C0}"/>
                </a:ext>
              </a:extLst>
            </p:cNvPr>
            <p:cNvSpPr txBox="1"/>
            <p:nvPr/>
          </p:nvSpPr>
          <p:spPr>
            <a:xfrm>
              <a:off x="847609" y="532366"/>
              <a:ext cx="9300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tility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4EA3304-8954-E71A-0ADF-CB5075632632}"/>
                </a:ext>
              </a:extLst>
            </p:cNvPr>
            <p:cNvSpPr txBox="1"/>
            <p:nvPr/>
          </p:nvSpPr>
          <p:spPr>
            <a:xfrm>
              <a:off x="4011566" y="532366"/>
              <a:ext cx="18822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ve  Motilit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6706855-E7DE-5B14-8AD7-9B14B51247AD}"/>
              </a:ext>
            </a:extLst>
          </p:cNvPr>
          <p:cNvGrpSpPr/>
          <p:nvPr/>
        </p:nvGrpSpPr>
        <p:grpSpPr>
          <a:xfrm>
            <a:off x="490713" y="5332784"/>
            <a:ext cx="4546067" cy="307777"/>
            <a:chOff x="847609" y="532366"/>
            <a:chExt cx="4546067" cy="307777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72E65E9-246C-A93F-0BA7-C2A6333E24E7}"/>
                </a:ext>
              </a:extLst>
            </p:cNvPr>
            <p:cNvSpPr txBox="1"/>
            <p:nvPr/>
          </p:nvSpPr>
          <p:spPr>
            <a:xfrm>
              <a:off x="847609" y="532366"/>
              <a:ext cx="991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Vitality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6D4DA4D-DB20-BC46-3A88-C159999BD774}"/>
                </a:ext>
              </a:extLst>
            </p:cNvPr>
            <p:cNvSpPr txBox="1"/>
            <p:nvPr/>
          </p:nvSpPr>
          <p:spPr>
            <a:xfrm>
              <a:off x="4011566" y="532366"/>
              <a:ext cx="1382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 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NA damage 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F93994A-8CE8-FF29-297C-301BFBBD5E22}"/>
              </a:ext>
            </a:extLst>
          </p:cNvPr>
          <p:cNvGrpSpPr/>
          <p:nvPr/>
        </p:nvGrpSpPr>
        <p:grpSpPr>
          <a:xfrm>
            <a:off x="490713" y="4262763"/>
            <a:ext cx="2367956" cy="523436"/>
            <a:chOff x="1156525" y="3617753"/>
            <a:chExt cx="2367956" cy="523436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6681934-2DA9-83DE-2FC7-138295F71AB6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24" name="Left Bracket 23">
              <a:extLst>
                <a:ext uri="{FF2B5EF4-FFF2-40B4-BE49-F238E27FC236}">
                  <a16:creationId xmlns:a16="http://schemas.microsoft.com/office/drawing/2014/main" id="{B1780281-3F82-EC80-2CF7-60857B0DDDB6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B15FBB9-1F7C-B06D-6A35-C8BDBB169BCD}"/>
                </a:ext>
              </a:extLst>
            </p:cNvPr>
            <p:cNvSpPr txBox="1"/>
            <p:nvPr/>
          </p:nvSpPr>
          <p:spPr>
            <a:xfrm>
              <a:off x="1915988" y="3910357"/>
              <a:ext cx="1347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rgothioneine (mM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DCB9887-5510-E752-338F-C7FE485A3D2A}"/>
                </a:ext>
              </a:extLst>
            </p:cNvPr>
            <p:cNvSpPr txBox="1"/>
            <p:nvPr/>
          </p:nvSpPr>
          <p:spPr>
            <a:xfrm>
              <a:off x="1156525" y="3617753"/>
              <a:ext cx="23679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4            6               8           Q 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865D32B0-71CB-418C-B0ED-E55F0D2B3CBC}"/>
              </a:ext>
            </a:extLst>
          </p:cNvPr>
          <p:cNvGrpSpPr/>
          <p:nvPr/>
        </p:nvGrpSpPr>
        <p:grpSpPr>
          <a:xfrm>
            <a:off x="3783348" y="4257020"/>
            <a:ext cx="2367956" cy="523436"/>
            <a:chOff x="1156525" y="3617753"/>
            <a:chExt cx="2367956" cy="523436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5955810-5866-1200-8BD9-DA83C730B99B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29" name="Left Bracket 28">
              <a:extLst>
                <a:ext uri="{FF2B5EF4-FFF2-40B4-BE49-F238E27FC236}">
                  <a16:creationId xmlns:a16="http://schemas.microsoft.com/office/drawing/2014/main" id="{F7FAA1BE-6676-AA31-FF92-22CB1A57CB93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A0D2528-D79C-91F5-4569-02D30EF51CC7}"/>
                </a:ext>
              </a:extLst>
            </p:cNvPr>
            <p:cNvSpPr txBox="1"/>
            <p:nvPr/>
          </p:nvSpPr>
          <p:spPr>
            <a:xfrm>
              <a:off x="1915988" y="3910357"/>
              <a:ext cx="1347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rgothioneine (mM)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00AC72F-F92C-7031-DD06-265820861846}"/>
                </a:ext>
              </a:extLst>
            </p:cNvPr>
            <p:cNvSpPr txBox="1"/>
            <p:nvPr/>
          </p:nvSpPr>
          <p:spPr>
            <a:xfrm>
              <a:off x="1156525" y="3617753"/>
              <a:ext cx="23679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4            6               8           Q 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899EBA69-E9DB-0973-5FB6-8690AF532F8A}"/>
              </a:ext>
            </a:extLst>
          </p:cNvPr>
          <p:cNvGrpSpPr/>
          <p:nvPr/>
        </p:nvGrpSpPr>
        <p:grpSpPr>
          <a:xfrm>
            <a:off x="481105" y="8364221"/>
            <a:ext cx="2367956" cy="523436"/>
            <a:chOff x="1156525" y="3617753"/>
            <a:chExt cx="2367956" cy="523436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9A7DEA0-D3EB-1182-F196-77289AB0D1B5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34" name="Left Bracket 33">
              <a:extLst>
                <a:ext uri="{FF2B5EF4-FFF2-40B4-BE49-F238E27FC236}">
                  <a16:creationId xmlns:a16="http://schemas.microsoft.com/office/drawing/2014/main" id="{D0EB7F0D-3A31-F756-BAB4-AE5BAA56E3FE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2DEBB7F-B030-B069-D920-6E7606A2DBCF}"/>
                </a:ext>
              </a:extLst>
            </p:cNvPr>
            <p:cNvSpPr txBox="1"/>
            <p:nvPr/>
          </p:nvSpPr>
          <p:spPr>
            <a:xfrm>
              <a:off x="1915988" y="3910357"/>
              <a:ext cx="1347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rgothioneine (mM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EA713A0-B2A0-C3F6-B62B-D74A03718EA4}"/>
                </a:ext>
              </a:extLst>
            </p:cNvPr>
            <p:cNvSpPr txBox="1"/>
            <p:nvPr/>
          </p:nvSpPr>
          <p:spPr>
            <a:xfrm>
              <a:off x="1156525" y="3617753"/>
              <a:ext cx="23679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4            6               8           Q 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02A4A065-3EFA-7330-E34F-FF136C8A824F}"/>
              </a:ext>
            </a:extLst>
          </p:cNvPr>
          <p:cNvGrpSpPr/>
          <p:nvPr/>
        </p:nvGrpSpPr>
        <p:grpSpPr>
          <a:xfrm>
            <a:off x="3710372" y="8410163"/>
            <a:ext cx="2367956" cy="523436"/>
            <a:chOff x="1156525" y="3617753"/>
            <a:chExt cx="2367956" cy="523436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9A532CC-00BC-8C0C-97CE-CDC5ABB56ACE}"/>
                </a:ext>
              </a:extLst>
            </p:cNvPr>
            <p:cNvSpPr txBox="1"/>
            <p:nvPr/>
          </p:nvSpPr>
          <p:spPr>
            <a:xfrm>
              <a:off x="1310527" y="377957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</a:p>
          </p:txBody>
        </p:sp>
        <p:sp>
          <p:nvSpPr>
            <p:cNvPr id="39" name="Left Bracket 38">
              <a:extLst>
                <a:ext uri="{FF2B5EF4-FFF2-40B4-BE49-F238E27FC236}">
                  <a16:creationId xmlns:a16="http://schemas.microsoft.com/office/drawing/2014/main" id="{DFBBC78A-431E-8465-3122-590CD92FD35E}"/>
                </a:ext>
              </a:extLst>
            </p:cNvPr>
            <p:cNvSpPr/>
            <p:nvPr/>
          </p:nvSpPr>
          <p:spPr>
            <a:xfrm rot="5400000">
              <a:off x="2355865" y="3208357"/>
              <a:ext cx="36000" cy="1368000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9306F84-270D-2214-F04D-A6DD2F5D75AC}"/>
                </a:ext>
              </a:extLst>
            </p:cNvPr>
            <p:cNvSpPr txBox="1"/>
            <p:nvPr/>
          </p:nvSpPr>
          <p:spPr>
            <a:xfrm>
              <a:off x="1915988" y="3910357"/>
              <a:ext cx="1347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rgothioneine (mM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9B34346-9E16-801E-8435-FDBB84D1A433}"/>
                </a:ext>
              </a:extLst>
            </p:cNvPr>
            <p:cNvSpPr txBox="1"/>
            <p:nvPr/>
          </p:nvSpPr>
          <p:spPr>
            <a:xfrm>
              <a:off x="1156525" y="3617753"/>
              <a:ext cx="23679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M+EC     4            6               8           Q 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21AB7B90-A963-F331-C09C-A05532619FDF}"/>
              </a:ext>
            </a:extLst>
          </p:cNvPr>
          <p:cNvSpPr txBox="1"/>
          <p:nvPr/>
        </p:nvSpPr>
        <p:spPr>
          <a:xfrm>
            <a:off x="5026131" y="9092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9855296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BA08486-AD15-00EB-5F93-DEBD313312E4}"/>
              </a:ext>
            </a:extLst>
          </p:cNvPr>
          <p:cNvGraphicFramePr>
            <a:graphicFrameLocks/>
          </p:cNvGraphicFramePr>
          <p:nvPr/>
        </p:nvGraphicFramePr>
        <p:xfrm>
          <a:off x="3379563" y="5296568"/>
          <a:ext cx="4572000" cy="38716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CF0B4B9-10B1-470F-FBDB-6A2820CA6709}"/>
              </a:ext>
            </a:extLst>
          </p:cNvPr>
          <p:cNvGraphicFramePr>
            <a:graphicFrameLocks/>
          </p:cNvGraphicFramePr>
          <p:nvPr/>
        </p:nvGraphicFramePr>
        <p:xfrm>
          <a:off x="-1159436" y="5060577"/>
          <a:ext cx="5229719" cy="37838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6906E95-458D-DFC0-4730-30969853E309}"/>
              </a:ext>
            </a:extLst>
          </p:cNvPr>
          <p:cNvGraphicFramePr>
            <a:graphicFrameLocks/>
          </p:cNvGraphicFramePr>
          <p:nvPr/>
        </p:nvGraphicFramePr>
        <p:xfrm>
          <a:off x="2783629" y="960276"/>
          <a:ext cx="4572000" cy="38716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696DF01-EA5A-2BC3-A273-7D9C55D4A2CA}"/>
              </a:ext>
            </a:extLst>
          </p:cNvPr>
          <p:cNvGraphicFramePr>
            <a:graphicFrameLocks/>
          </p:cNvGraphicFramePr>
          <p:nvPr/>
        </p:nvGraphicFramePr>
        <p:xfrm>
          <a:off x="-1278967" y="962526"/>
          <a:ext cx="5430779" cy="40920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2516A77-5ED9-FD83-B554-170351F5F7A9}"/>
              </a:ext>
            </a:extLst>
          </p:cNvPr>
          <p:cNvSpPr txBox="1"/>
          <p:nvPr/>
        </p:nvSpPr>
        <p:spPr>
          <a:xfrm rot="16200000">
            <a:off x="48826" y="2409937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tility (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EAFD8D-47C7-E3F5-D406-CDF2BBB15AF7}"/>
              </a:ext>
            </a:extLst>
          </p:cNvPr>
          <p:cNvSpPr txBox="1"/>
          <p:nvPr/>
        </p:nvSpPr>
        <p:spPr>
          <a:xfrm rot="16200000">
            <a:off x="2822324" y="2614293"/>
            <a:ext cx="1797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gressive motility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9119786-F1C5-70DC-82BC-1D5A6203B4DF}"/>
              </a:ext>
            </a:extLst>
          </p:cNvPr>
          <p:cNvSpPr txBox="1"/>
          <p:nvPr/>
        </p:nvSpPr>
        <p:spPr>
          <a:xfrm rot="16200000">
            <a:off x="40313" y="6684222"/>
            <a:ext cx="959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tality  (%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001AB0-E527-62A7-4D2B-B83389A07DC6}"/>
              </a:ext>
            </a:extLst>
          </p:cNvPr>
          <p:cNvSpPr txBox="1"/>
          <p:nvPr/>
        </p:nvSpPr>
        <p:spPr>
          <a:xfrm rot="16200000">
            <a:off x="3014561" y="6642329"/>
            <a:ext cx="1421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 damage  (%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CD72DFC0-64F2-ACAF-3A68-88A30E363372}"/>
              </a:ext>
            </a:extLst>
          </p:cNvPr>
          <p:cNvGrpSpPr/>
          <p:nvPr/>
        </p:nvGrpSpPr>
        <p:grpSpPr>
          <a:xfrm>
            <a:off x="845092" y="1204494"/>
            <a:ext cx="5046204" cy="307777"/>
            <a:chOff x="847609" y="532366"/>
            <a:chExt cx="5046204" cy="307777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B8A7BBB-AA0B-BFDF-2134-C4F15010576F}"/>
                </a:ext>
              </a:extLst>
            </p:cNvPr>
            <p:cNvSpPr txBox="1"/>
            <p:nvPr/>
          </p:nvSpPr>
          <p:spPr>
            <a:xfrm>
              <a:off x="847609" y="532366"/>
              <a:ext cx="9300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tility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C7FD0DF-D169-D8AA-770A-02C49A656ED0}"/>
                </a:ext>
              </a:extLst>
            </p:cNvPr>
            <p:cNvSpPr txBox="1"/>
            <p:nvPr/>
          </p:nvSpPr>
          <p:spPr>
            <a:xfrm>
              <a:off x="4011566" y="532366"/>
              <a:ext cx="18822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ve  Motilit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E66BA15-7962-72A7-D816-CF6826E30DFB}"/>
              </a:ext>
            </a:extLst>
          </p:cNvPr>
          <p:cNvGrpSpPr/>
          <p:nvPr/>
        </p:nvGrpSpPr>
        <p:grpSpPr>
          <a:xfrm>
            <a:off x="840335" y="5332784"/>
            <a:ext cx="4546067" cy="307777"/>
            <a:chOff x="847609" y="532366"/>
            <a:chExt cx="4546067" cy="307777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5AEC6A-D519-FE13-452A-BDFE25E838D2}"/>
                </a:ext>
              </a:extLst>
            </p:cNvPr>
            <p:cNvSpPr txBox="1"/>
            <p:nvPr/>
          </p:nvSpPr>
          <p:spPr>
            <a:xfrm>
              <a:off x="847609" y="532366"/>
              <a:ext cx="991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Vitality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17CF5ED-6310-FFF3-4639-1BA7B722D02B}"/>
                </a:ext>
              </a:extLst>
            </p:cNvPr>
            <p:cNvSpPr txBox="1"/>
            <p:nvPr/>
          </p:nvSpPr>
          <p:spPr>
            <a:xfrm>
              <a:off x="4011566" y="532366"/>
              <a:ext cx="1382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  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NA damage 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C6821FBA-1E6A-04E1-B279-0DF955FB8396}"/>
              </a:ext>
            </a:extLst>
          </p:cNvPr>
          <p:cNvSpPr txBox="1"/>
          <p:nvPr/>
        </p:nvSpPr>
        <p:spPr>
          <a:xfrm>
            <a:off x="5104102" y="112817"/>
            <a:ext cx="16097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</a:p>
        </p:txBody>
      </p:sp>
    </p:spTree>
    <p:extLst>
      <p:ext uri="{BB962C8B-B14F-4D97-AF65-F5344CB8AC3E}">
        <p14:creationId xmlns:p14="http://schemas.microsoft.com/office/powerpoint/2010/main" val="1288920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262</Words>
  <Application>Microsoft Macintosh PowerPoint</Application>
  <PresentationFormat>A4 Paper (210x297 mm)</PresentationFormat>
  <Paragraphs>7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Supplementary Figures 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hn Aitken</dc:creator>
  <cp:lastModifiedBy>John  Aitken</cp:lastModifiedBy>
  <cp:revision>5</cp:revision>
  <dcterms:created xsi:type="dcterms:W3CDTF">2024-08-29T04:23:36Z</dcterms:created>
  <dcterms:modified xsi:type="dcterms:W3CDTF">2025-04-14T22:21:35Z</dcterms:modified>
</cp:coreProperties>
</file>